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074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31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118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7424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4069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4412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490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47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146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1649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7552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26A30-8A16-4C95-B2D7-29F6BA85842B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D53652-3B28-4D6D-B4C1-33DEB75FB6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0473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314733" y="272634"/>
            <a:ext cx="952158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b="1" kern="10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b="1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kern="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onship between the mutations in different signaling pathways and the level of PD-L1 expression.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图片 2" descr="092013322217_0pathway_1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7102" y="1472963"/>
            <a:ext cx="5276850" cy="527685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925619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丁</dc:creator>
  <cp:lastModifiedBy>张丁</cp:lastModifiedBy>
  <cp:revision>3</cp:revision>
  <dcterms:created xsi:type="dcterms:W3CDTF">2020-10-15T01:24:47Z</dcterms:created>
  <dcterms:modified xsi:type="dcterms:W3CDTF">2023-10-08T01:59:07Z</dcterms:modified>
</cp:coreProperties>
</file>